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78" autoAdjust="0"/>
    <p:restoredTop sz="94660"/>
  </p:normalViewPr>
  <p:slideViewPr>
    <p:cSldViewPr snapToGrid="0">
      <p:cViewPr>
        <p:scale>
          <a:sx n="59" d="100"/>
          <a:sy n="59" d="100"/>
        </p:scale>
        <p:origin x="-1188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109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20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1447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8289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19478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50528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2770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181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828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06218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3365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4A863A-1FFC-42DA-86E8-12B2D5CEFA5B}" type="datetimeFigureOut">
              <a:rPr lang="en-US" smtClean="0"/>
              <a:t>5/1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58C9748-FF1F-4BD5-BEA1-432702066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9900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/>
          <p:cNvGrpSpPr/>
          <p:nvPr/>
        </p:nvGrpSpPr>
        <p:grpSpPr>
          <a:xfrm>
            <a:off x="3685303" y="1280831"/>
            <a:ext cx="4490986" cy="2961162"/>
            <a:chOff x="3731485" y="431086"/>
            <a:chExt cx="4490986" cy="2961162"/>
          </a:xfrm>
        </p:grpSpPr>
        <p:grpSp>
          <p:nvGrpSpPr>
            <p:cNvPr id="13" name="Group 12"/>
            <p:cNvGrpSpPr/>
            <p:nvPr/>
          </p:nvGrpSpPr>
          <p:grpSpPr>
            <a:xfrm>
              <a:off x="3731485" y="581891"/>
              <a:ext cx="1246045" cy="2810357"/>
              <a:chOff x="3731485" y="581891"/>
              <a:chExt cx="1246045" cy="2810357"/>
            </a:xfrm>
          </p:grpSpPr>
          <p:grpSp>
            <p:nvGrpSpPr>
              <p:cNvPr id="4" name="Group 3"/>
              <p:cNvGrpSpPr/>
              <p:nvPr/>
            </p:nvGrpSpPr>
            <p:grpSpPr>
              <a:xfrm>
                <a:off x="3731485" y="581891"/>
                <a:ext cx="1246045" cy="2810357"/>
                <a:chOff x="6032728" y="1361090"/>
                <a:chExt cx="1179278" cy="2035253"/>
              </a:xfrm>
            </p:grpSpPr>
            <p:pic>
              <p:nvPicPr>
                <p:cNvPr id="10" name="Picture 9"/>
                <p:cNvPicPr>
                  <a:picLocks noChangeAspect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/>
              </p:blipFill>
              <p:spPr>
                <a:xfrm>
                  <a:off x="6675483" y="1361090"/>
                  <a:ext cx="536523" cy="2035253"/>
                </a:xfrm>
                <a:prstGeom prst="rect">
                  <a:avLst/>
                </a:prstGeom>
              </p:spPr>
            </p:pic>
            <p:sp>
              <p:nvSpPr>
                <p:cNvPr id="11" name="TextBox 10"/>
                <p:cNvSpPr txBox="1"/>
                <p:nvPr/>
              </p:nvSpPr>
              <p:spPr>
                <a:xfrm>
                  <a:off x="6032728" y="2064112"/>
                  <a:ext cx="725538" cy="1894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charset="0"/>
                      <a:ea typeface="Arial" charset="0"/>
                      <a:cs typeface="Arial" charset="0"/>
                    </a:rPr>
                    <a:t>28s RNA</a:t>
                  </a: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6032728" y="2297178"/>
                  <a:ext cx="710311" cy="1894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100" dirty="0">
                      <a:latin typeface="Arial" charset="0"/>
                      <a:ea typeface="Arial" charset="0"/>
                      <a:cs typeface="Arial" charset="0"/>
                    </a:rPr>
                    <a:t>18s RNA</a:t>
                  </a:r>
                </a:p>
              </p:txBody>
            </p:sp>
          </p:grpSp>
          <p:sp>
            <p:nvSpPr>
              <p:cNvPr id="8" name="TextBox 7"/>
              <p:cNvSpPr txBox="1"/>
              <p:nvPr/>
            </p:nvSpPr>
            <p:spPr>
              <a:xfrm>
                <a:off x="4592491" y="600363"/>
                <a:ext cx="278297" cy="3039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 charset="0"/>
                    <a:ea typeface="Arial" charset="0"/>
                    <a:cs typeface="Arial" charset="0"/>
                  </a:rPr>
                  <a:t>L</a:t>
                </a: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5712096" y="580827"/>
              <a:ext cx="2510375" cy="2774476"/>
              <a:chOff x="3870085" y="1847206"/>
              <a:chExt cx="2138731" cy="2101940"/>
            </a:xfrm>
          </p:grpSpPr>
          <p:pic>
            <p:nvPicPr>
              <p:cNvPr id="15" name="Picture 14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8579"/>
              <a:stretch/>
            </p:blipFill>
            <p:spPr>
              <a:xfrm>
                <a:off x="3870085" y="1847206"/>
                <a:ext cx="1985273" cy="2101940"/>
              </a:xfrm>
              <a:prstGeom prst="rect">
                <a:avLst/>
              </a:prstGeom>
            </p:spPr>
          </p:pic>
          <p:sp>
            <p:nvSpPr>
              <p:cNvPr id="19" name="TextBox 18"/>
              <p:cNvSpPr txBox="1"/>
              <p:nvPr/>
            </p:nvSpPr>
            <p:spPr>
              <a:xfrm>
                <a:off x="3884468" y="1916903"/>
                <a:ext cx="2124348" cy="2098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200" dirty="0">
                    <a:latin typeface="Arial" charset="0"/>
                    <a:ea typeface="Arial" charset="0"/>
                    <a:cs typeface="Arial" charset="0"/>
                  </a:rPr>
                  <a:t>  M            1            2          3                   </a:t>
                </a:r>
              </a:p>
            </p:txBody>
          </p:sp>
        </p:grpSp>
        <p:sp>
          <p:nvSpPr>
            <p:cNvPr id="20" name="TextBox 19"/>
            <p:cNvSpPr txBox="1"/>
            <p:nvPr/>
          </p:nvSpPr>
          <p:spPr>
            <a:xfrm>
              <a:off x="3986653" y="432969"/>
              <a:ext cx="3432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a-DK" sz="1600" b="1" dirty="0"/>
                <a:t>A</a:t>
              </a:r>
              <a:endParaRPr lang="en-US" sz="16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5387538" y="431086"/>
              <a:ext cx="34327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a-DK" sz="1600" b="1" dirty="0"/>
                <a:t>B</a:t>
              </a:r>
              <a:endParaRPr lang="en-US" sz="1600" b="1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796835" y="4297045"/>
            <a:ext cx="10058400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Figure </a:t>
            </a:r>
            <a:r>
              <a:rPr lang="en-US" b="1" smtClean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S1: 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Total leaf RNA and PCR amplification of </a:t>
            </a:r>
            <a:r>
              <a:rPr lang="en-US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 genes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(A)</a:t>
            </a:r>
            <a:r>
              <a:rPr lang="en-US" b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Denaturing agarose gel showing RNA isolated from the leaf tissue of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rabidopsis thaliana.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The quality of RNA was checked by electrophoresing on formaldehyde based denaturing agarose gel to observe the integrity of 28s and 18s </a:t>
            </a:r>
            <a:r>
              <a:rPr lang="en-US" dirty="0" err="1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rRNA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 bands. Here L stands for leaf tissue. (B) EtBr stained 1% agarose gel showing eluted full-length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 genes PCR products amplified using gene specific forward and reverse primers with attB1 and attB2 sequences. Expected band corresponding to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2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(558bp),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3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(853bp) and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6 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(1053bp) genes are labeled on the gel based on their size. Here M: 1kb DNA ladder; Lane 1: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2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; Lane 2: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3</a:t>
            </a:r>
            <a:r>
              <a:rPr lang="en-US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; Lane 3: </a:t>
            </a:r>
            <a:r>
              <a:rPr lang="en-US" i="1" dirty="0">
                <a:solidFill>
                  <a:srgbClr val="000000"/>
                </a:solidFill>
                <a:latin typeface="Times New Roman" panose="02020603050405020304" pitchFamily="18" charset="0"/>
                <a:ea typeface="Times" panose="02020603050405020304" pitchFamily="18" charset="0"/>
              </a:rPr>
              <a:t>AtGLYI6</a:t>
            </a:r>
            <a:endParaRPr lang="en-IN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495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47</TotalTime>
  <Words>152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D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ituraj Batth</dc:creator>
  <cp:lastModifiedBy>Vijayakumar AG</cp:lastModifiedBy>
  <cp:revision>103</cp:revision>
  <dcterms:created xsi:type="dcterms:W3CDTF">2019-10-06T16:26:31Z</dcterms:created>
  <dcterms:modified xsi:type="dcterms:W3CDTF">2020-05-18T18:53:49Z</dcterms:modified>
</cp:coreProperties>
</file>